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29ADCB-5920-495D-9185-8F9FB9D7040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89C4E6-9858-46A2-A322-6728798F0F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F9F322-C53C-418F-B934-1F6A5249006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C5E389-D86A-4F0B-9C69-80DB2FFDD93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E3A15F-4629-408E-BC43-5EFED66B00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6B7619-2F1D-46E1-A306-FF111257E6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DCA532-6F97-426C-9C63-CC0A829831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433B7D-B4F5-4012-A6F9-B606A44D3B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409073-DB11-474B-9B80-D830A6F29F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7C7080-0032-4CE9-9D48-DC436C1047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1502E8-C27C-4286-B7D3-72BDA4C14A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E3BC3A-2755-4C09-9158-F43F19C870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CD79207-FAE6-414E-A4B1-25FE97360FD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-27000" y="65160"/>
          <a:ext cx="6669000" cy="48672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-27000" y="65160"/>
                    <a:ext cx="6669000" cy="4867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669960" y="4859280"/>
          <a:ext cx="5138640" cy="426240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669960" y="4859280"/>
                    <a:ext cx="5138640" cy="4262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" name=""/>
          <p:cNvSpPr/>
          <p:nvPr/>
        </p:nvSpPr>
        <p:spPr>
          <a:xfrm>
            <a:off x="262440" y="34776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78080" y="459108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"/>
          <p:cNvSpPr/>
          <p:nvPr/>
        </p:nvSpPr>
        <p:spPr>
          <a:xfrm>
            <a:off x="333360" y="324000"/>
            <a:ext cx="5904000" cy="201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1: a) Connectivity versus deletion. The figure shows the number of proteins in the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E.coli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network with a given number of connections (partners), and their conservation or deletion in the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Buchnera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network. Deleted nodes are mainly those with few connections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) Probability of the deletion of nodes (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pdel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) as a function of the probable number of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nnections (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k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)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5-15T13:10:10Z</dcterms:created>
  <dc:creator>Javier</dc:creator>
  <dc:description/>
  <dc:language>en-US</dc:language>
  <cp:lastModifiedBy>Javier</cp:lastModifiedBy>
  <dcterms:modified xsi:type="dcterms:W3CDTF">2007-05-17T10:51:27Z</dcterms:modified>
  <cp:revision>8</cp:revision>
  <dc:subject/>
  <dc:title>Diapositiva 1</dc:title>
</cp:coreProperties>
</file>